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ACCC5-8CFC-425A-BC8D-7B599D00BE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B98D9A-D0DC-4D56-BF73-20CB92CC30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351FE-6090-488E-B2AC-4BD723663D6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F271B-3BED-4932-B96D-880BB2487E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FB24F-9522-443B-9BD1-0282842366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96C9C-59CA-4DDC-A994-26981AD941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67DCDA-D3F0-4F4C-9559-74996D3FFB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5A42C-4A13-41D7-A532-E93ACD06A0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20BF4C-0041-41D0-AF46-0B9023CF12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55C69-F454-41FC-9B0A-1A89E5DDF3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2403C-CB73-4F31-B637-F54D8A273F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EA7D8-868C-42D7-8F2D-379A884839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CC8CD18-849C-4210-B788-697EC40464D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709560" y="76320"/>
            <a:ext cx="5462640" cy="8305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89080" y="8381880"/>
            <a:ext cx="64166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9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dentity score between adjacent LRRs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amoebophil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The average of the identity scores is calculated between pairs of amino acid sequences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or of nucleotide sequences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of each 18 repeats of LgrE of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amoebophila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its two closest repeats (in gray) and all 17 other repeats (black squares). In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he difference existing between the average identity scores calculated from all LRRs and from pairs of LRRs separated by zero to seven 28-meric intercalary repeats. All together, these three figures reveal that the adjacent LRRs are closely related.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3T09:22:55Z</dcterms:created>
  <dc:creator>Gilbert Greub</dc:creator>
  <dc:description/>
  <dc:language>en-US</dc:language>
  <cp:lastModifiedBy>Gilbert Greub</cp:lastModifiedBy>
  <dcterms:modified xsi:type="dcterms:W3CDTF">2007-11-14T18:38:45Z</dcterms:modified>
  <cp:revision>17</cp:revision>
  <dc:subject/>
  <dc:title>Présentation PowerPoint</dc:title>
</cp:coreProperties>
</file>